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87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8" y="4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421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377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019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784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4163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975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938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797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526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159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477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B7BD4-7AEB-4B6C-AC7A-8465E5DFEA3C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F6739-9028-4E5D-9289-AA207416FD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5029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0285" y="6061243"/>
            <a:ext cx="5121915" cy="5097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sz="1600" u="sng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1: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low diagram of the patients included in the study</a:t>
            </a:r>
            <a:endParaRPr lang="en-GB" sz="16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867149" y="723900"/>
            <a:ext cx="3990975" cy="7016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2 consecutive patients </a:t>
            </a: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enrolled in the NOACISP </a:t>
            </a: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istry after an AF-related acute ischemic stroke or TIA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5852317" y="1425550"/>
            <a:ext cx="20638" cy="18173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4969985" y="2371725"/>
            <a:ext cx="88233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923765" y="1559572"/>
            <a:ext cx="4046220" cy="16243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(n=62)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2 patients did not have an MRI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 patients had insufficient MRI-quality (e.g. motion artefacts)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patients without follow-up of at least 3 months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patients had insufficient </a:t>
            </a: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WI sequences to </a:t>
            </a: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termine CMBs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patients were only treated with </a:t>
            </a:r>
            <a:r>
              <a:rPr lang="en-GB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platelets</a:t>
            </a:r>
            <a:endParaRPr lang="en-GB" sz="12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4894657" y="3242231"/>
            <a:ext cx="1956595" cy="5225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lete data set (n=310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243125" y="4781634"/>
            <a:ext cx="1308958" cy="4347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out CMBs (n=224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2888094" y="4799017"/>
            <a:ext cx="1311049" cy="4347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CMBs (n=86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Straight Arrow Connector 41"/>
          <p:cNvCxnSpPr/>
          <p:nvPr/>
        </p:nvCxnSpPr>
        <p:spPr>
          <a:xfrm flipH="1">
            <a:off x="3782530" y="4455706"/>
            <a:ext cx="372910" cy="325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4158042" y="4466239"/>
            <a:ext cx="326696" cy="3153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5568350" y="5377692"/>
            <a:ext cx="1207699" cy="3418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KA treatment (n=20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5568350" y="5828102"/>
            <a:ext cx="1251902" cy="338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AC treatment (n=66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Straight Connector 50"/>
          <p:cNvCxnSpPr/>
          <p:nvPr/>
        </p:nvCxnSpPr>
        <p:spPr>
          <a:xfrm>
            <a:off x="3555847" y="5241067"/>
            <a:ext cx="1537867" cy="52145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>
            <a:off x="7299171" y="4463182"/>
            <a:ext cx="364072" cy="3076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7660640" y="4455706"/>
            <a:ext cx="363228" cy="3076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/>
          <p:cNvSpPr/>
          <p:nvPr/>
        </p:nvSpPr>
        <p:spPr>
          <a:xfrm>
            <a:off x="1587023" y="4002112"/>
            <a:ext cx="1956595" cy="3000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tegorization by CMBs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8278121" y="4002112"/>
            <a:ext cx="1956595" cy="2968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tegorization by treatment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 flipH="1">
            <a:off x="4155440" y="3774818"/>
            <a:ext cx="1158396" cy="67088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6319676" y="3774818"/>
            <a:ext cx="1340964" cy="6808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6562487" y="4815816"/>
            <a:ext cx="1227810" cy="3418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KA treatment (n=76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7921680" y="4799017"/>
            <a:ext cx="1334739" cy="3418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AC treatment (n=234)</a:t>
            </a:r>
            <a:endParaRPr lang="en-GB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Connector 37"/>
          <p:cNvCxnSpPr>
            <a:stCxn id="49" idx="1"/>
          </p:cNvCxnSpPr>
          <p:nvPr/>
        </p:nvCxnSpPr>
        <p:spPr>
          <a:xfrm flipH="1" flipV="1">
            <a:off x="5093723" y="5771545"/>
            <a:ext cx="474627" cy="22566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/>
          <p:cNvCxnSpPr>
            <a:stCxn id="49" idx="3"/>
          </p:cNvCxnSpPr>
          <p:nvPr/>
        </p:nvCxnSpPr>
        <p:spPr>
          <a:xfrm flipV="1">
            <a:off x="6820252" y="5152847"/>
            <a:ext cx="1838138" cy="8443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/>
          <p:cNvCxnSpPr>
            <a:stCxn id="32" idx="2"/>
            <a:endCxn id="48" idx="3"/>
          </p:cNvCxnSpPr>
          <p:nvPr/>
        </p:nvCxnSpPr>
        <p:spPr>
          <a:xfrm flipH="1">
            <a:off x="6776049" y="5157688"/>
            <a:ext cx="400343" cy="39094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V="1">
            <a:off x="5109981" y="5508999"/>
            <a:ext cx="442102" cy="26254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78678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20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jamin Wagner</dc:creator>
  <cp:lastModifiedBy>Benjamin Wagner</cp:lastModifiedBy>
  <cp:revision>13</cp:revision>
  <dcterms:created xsi:type="dcterms:W3CDTF">2022-07-06T22:47:14Z</dcterms:created>
  <dcterms:modified xsi:type="dcterms:W3CDTF">2022-08-31T00:21:58Z</dcterms:modified>
</cp:coreProperties>
</file>